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6" r:id="rId2"/>
  </p:sldIdLst>
  <p:sldSz cx="9144000" cy="77406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03"/>
    <p:restoredTop sz="89252"/>
  </p:normalViewPr>
  <p:slideViewPr>
    <p:cSldViewPr snapToGrid="0" snapToObjects="1">
      <p:cViewPr varScale="1">
        <p:scale>
          <a:sx n="100" d="100"/>
          <a:sy n="100" d="100"/>
        </p:scale>
        <p:origin x="228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B0EACF-48F0-5B4F-B4A1-8067BC58A3E0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606550" y="1143000"/>
            <a:ext cx="36449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5BE75B-1058-4F43-83B3-24D50C6F6A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12226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606550" y="1143000"/>
            <a:ext cx="36449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/>
              <a:t>Supplementary figure 4</a:t>
            </a:r>
          </a:p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B5BE75B-1058-4F43-83B3-24D50C6F6AF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26081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266815"/>
            <a:ext cx="7772400" cy="2694893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4065633"/>
            <a:ext cx="6858000" cy="1868865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1486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1586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412118"/>
            <a:ext cx="1971675" cy="655984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412118"/>
            <a:ext cx="5800725" cy="655984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07164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50592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929789"/>
            <a:ext cx="7886700" cy="3219895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5180145"/>
            <a:ext cx="7886700" cy="169326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2853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060590"/>
            <a:ext cx="3886200" cy="491137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060590"/>
            <a:ext cx="3886200" cy="491137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2627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12120"/>
            <a:ext cx="7886700" cy="149616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897535"/>
            <a:ext cx="3868340" cy="9299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827487"/>
            <a:ext cx="3868340" cy="415880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897535"/>
            <a:ext cx="3887391" cy="9299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827487"/>
            <a:ext cx="3887391" cy="415880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04683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643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4126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16043"/>
            <a:ext cx="2949178" cy="180615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114512"/>
            <a:ext cx="4629150" cy="550087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322195"/>
            <a:ext cx="2949178" cy="43021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0750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16043"/>
            <a:ext cx="2949178" cy="180615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114512"/>
            <a:ext cx="4629150" cy="5500879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322195"/>
            <a:ext cx="2949178" cy="43021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96246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412120"/>
            <a:ext cx="7886700" cy="14961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2060590"/>
            <a:ext cx="7886700" cy="49113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7174437"/>
            <a:ext cx="2057400" cy="4121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7174437"/>
            <a:ext cx="3086100" cy="4121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7174437"/>
            <a:ext cx="2057400" cy="4121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1198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6A0A9AEE-EA40-AB4F-97E4-AD27A2FE2CD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692" b="6610"/>
          <a:stretch/>
        </p:blipFill>
        <p:spPr>
          <a:xfrm>
            <a:off x="1378770" y="-282573"/>
            <a:ext cx="6775670" cy="6855103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E871705-001F-D441-A413-B036BCAC6B28}"/>
              </a:ext>
            </a:extLst>
          </p:cNvPr>
          <p:cNvSpPr txBox="1"/>
          <p:nvPr/>
        </p:nvSpPr>
        <p:spPr>
          <a:xfrm>
            <a:off x="3036258" y="6226347"/>
            <a:ext cx="356985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H3K27me3 labelling index (%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E3B55F9-01FF-374B-86C5-D6228C2B22D8}"/>
              </a:ext>
            </a:extLst>
          </p:cNvPr>
          <p:cNvSpPr txBox="1"/>
          <p:nvPr/>
        </p:nvSpPr>
        <p:spPr>
          <a:xfrm rot="16200000">
            <a:off x="-225196" y="2965524"/>
            <a:ext cx="295392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R labelling index (%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42A5FC68-7146-7541-BF34-CA15A9372AA4}"/>
              </a:ext>
            </a:extLst>
          </p:cNvPr>
          <p:cNvCxnSpPr>
            <a:cxnSpLocks/>
          </p:cNvCxnSpPr>
          <p:nvPr/>
        </p:nvCxnSpPr>
        <p:spPr>
          <a:xfrm flipV="1">
            <a:off x="2092240" y="1574409"/>
            <a:ext cx="5672991" cy="2133098"/>
          </a:xfrm>
          <a:prstGeom prst="line">
            <a:avLst/>
          </a:prstGeom>
          <a:ln w="222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26E423EC-5917-C84A-91D5-591151FD571B}"/>
              </a:ext>
            </a:extLst>
          </p:cNvPr>
          <p:cNvSpPr/>
          <p:nvPr/>
        </p:nvSpPr>
        <p:spPr>
          <a:xfrm>
            <a:off x="203989" y="6595679"/>
            <a:ext cx="8736022" cy="7720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200" b="1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Supplementary Figure </a:t>
            </a:r>
            <a:r>
              <a:rPr lang="en-US" altLang="ja-JP" sz="1200" b="1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4. 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A weak positive correlation was found between the expression of H3K27me3 and androgen receptor (</a:t>
            </a:r>
            <a:r>
              <a:rPr lang="en-US" altLang="ja-JP" sz="1200" i="1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r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 = 0.350, </a:t>
            </a:r>
            <a:r>
              <a:rPr lang="en-US" altLang="ja-JP" sz="1200" i="1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P 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&lt; 0.001).</a:t>
            </a:r>
            <a:endParaRPr lang="ja-JP" altLang="ja-JP" sz="1200"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5240330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168</TotalTime>
  <Words>39</Words>
  <Application>Microsoft Macintosh PowerPoint</Application>
  <PresentationFormat>ユーザー設定</PresentationFormat>
  <Paragraphs>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平井 秀明</dc:creator>
  <cp:lastModifiedBy>平井 秀明</cp:lastModifiedBy>
  <cp:revision>90</cp:revision>
  <dcterms:created xsi:type="dcterms:W3CDTF">2020-07-01T13:22:00Z</dcterms:created>
  <dcterms:modified xsi:type="dcterms:W3CDTF">2021-09-20T00:14:53Z</dcterms:modified>
</cp:coreProperties>
</file>